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7/07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87005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13514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7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7420" y="5240962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 err="1">
                <a:solidFill>
                  <a:prstClr val="black"/>
                </a:solidFill>
                <a:latin typeface="Calibri"/>
              </a:rPr>
              <a:t>Solini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3) Diabetologia DOI 10.1007/s00125-0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3-05973-w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roposed direct mechanisms of cardiovascular protection exerted by pharmacological activation of GLP-1, GIP and glucagon receptor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EC49C93-51BE-52D5-F865-E8D19DE9A3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5353" y="1251920"/>
            <a:ext cx="6753293" cy="4354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7420" y="5240962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 err="1">
                <a:solidFill>
                  <a:prstClr val="black"/>
                </a:solidFill>
                <a:latin typeface="Calibri"/>
              </a:rPr>
              <a:t>Solini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 </a:t>
            </a:r>
            <a:r>
              <a:rPr kumimoji="0" lang="en-GB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3) Diabetologia DOI 10.1007/s00125-0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3-05973-w</a:t>
            </a:r>
            <a:r>
              <a:rPr kumimoji="0" lang="en-GB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Cardiovascular outcomes and all-cause mortality for GLP-1RA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96FC550-273A-3B30-F78A-437596936B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63184" y="692696"/>
            <a:ext cx="4417631" cy="50747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44550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7420" y="5240962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 err="1">
                <a:solidFill>
                  <a:prstClr val="black"/>
                </a:solidFill>
                <a:latin typeface="Calibri"/>
              </a:rPr>
              <a:t>Solini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 </a:t>
            </a:r>
            <a:r>
              <a:rPr kumimoji="0" lang="en-GB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et al (2023) Diabetologia DOI 10.1007/s00125-0</a:t>
            </a:r>
            <a:r>
              <a:rPr lang="en-GB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3-05973-w</a:t>
            </a:r>
            <a:r>
              <a:rPr kumimoji="0" lang="en-GB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3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8204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Generalisability of results from GLP-1RA CVOTs to the real-world type 2 diabetes populat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ED3A7B1-7F2E-74B2-C919-42F5D168A3C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7744" y="1340768"/>
            <a:ext cx="7737907" cy="4029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449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7</TotalTime>
  <Words>160</Words>
  <Application>Microsoft Office PowerPoint</Application>
  <PresentationFormat>On-screen Show (4:3)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44</cp:revision>
  <dcterms:created xsi:type="dcterms:W3CDTF">2016-06-15T12:53:43Z</dcterms:created>
  <dcterms:modified xsi:type="dcterms:W3CDTF">2023-07-27T08:50:21Z</dcterms:modified>
</cp:coreProperties>
</file>